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2" r:id="rId2"/>
    <p:sldId id="256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766"/>
    <p:restoredTop sz="96327"/>
  </p:normalViewPr>
  <p:slideViewPr>
    <p:cSldViewPr snapToGrid="0">
      <p:cViewPr varScale="1">
        <p:scale>
          <a:sx n="96" d="100"/>
          <a:sy n="96" d="100"/>
        </p:scale>
        <p:origin x="150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3CDE7-D510-B14A-9B89-777F062F608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24144-FAAE-1E41-B1B4-51598DF059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5778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3CDE7-D510-B14A-9B89-777F062F608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24144-FAAE-1E41-B1B4-51598DF059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43286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3CDE7-D510-B14A-9B89-777F062F608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24144-FAAE-1E41-B1B4-51598DF059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1091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3CDE7-D510-B14A-9B89-777F062F608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24144-FAAE-1E41-B1B4-51598DF059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68585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3CDE7-D510-B14A-9B89-777F062F608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24144-FAAE-1E41-B1B4-51598DF059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7855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3CDE7-D510-B14A-9B89-777F062F608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24144-FAAE-1E41-B1B4-51598DF059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51226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3CDE7-D510-B14A-9B89-777F062F608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24144-FAAE-1E41-B1B4-51598DF059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16961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3CDE7-D510-B14A-9B89-777F062F608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24144-FAAE-1E41-B1B4-51598DF059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0947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3CDE7-D510-B14A-9B89-777F062F608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24144-FAAE-1E41-B1B4-51598DF059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6110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3CDE7-D510-B14A-9B89-777F062F608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24144-FAAE-1E41-B1B4-51598DF059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89995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3CDE7-D510-B14A-9B89-777F062F608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24144-FAAE-1E41-B1B4-51598DF059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54093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03CDE7-D510-B14A-9B89-777F062F608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224144-FAAE-1E41-B1B4-51598DF059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0126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AE3C3EF4-9BF5-3248-9B94-93A5671E1ED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34978" y="266690"/>
            <a:ext cx="4552727" cy="569090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42E8E0B2-6728-2B40-9327-4AEC1A694EB7}"/>
              </a:ext>
            </a:extLst>
          </p:cNvPr>
          <p:cNvSpPr txBox="1"/>
          <p:nvPr/>
        </p:nvSpPr>
        <p:spPr>
          <a:xfrm>
            <a:off x="2504560" y="8600022"/>
            <a:ext cx="2031325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8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275B6D-D53D-254D-B470-55152F9CD1DB}"/>
              </a:ext>
            </a:extLst>
          </p:cNvPr>
          <p:cNvSpPr txBox="1"/>
          <p:nvPr/>
        </p:nvSpPr>
        <p:spPr>
          <a:xfrm>
            <a:off x="3305939" y="6091560"/>
            <a:ext cx="580331" cy="415755"/>
          </a:xfrm>
          <a:prstGeom prst="rect">
            <a:avLst/>
          </a:prstGeom>
          <a:solidFill>
            <a:schemeClr val="bg2">
              <a:lumMod val="5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sz="105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C43N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462D4DD-FDC0-8B43-BDA7-823E970626B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00162" y="6381623"/>
            <a:ext cx="1802782" cy="180278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E1993F9-FF26-D84B-9471-3A5E999A386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53341" y="6396012"/>
            <a:ext cx="1802782" cy="18027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369122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6C28EBF-C0D3-E059-E4E0-0AEF335CB645}"/>
              </a:ext>
            </a:extLst>
          </p:cNvPr>
          <p:cNvSpPr txBox="1"/>
          <p:nvPr/>
        </p:nvSpPr>
        <p:spPr>
          <a:xfrm>
            <a:off x="221974" y="348014"/>
            <a:ext cx="641405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Supplementary Figure 8. GSEA analyses.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The terms identified and visualized where the normalized enrichment score.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26873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</TotalTime>
  <Words>22</Words>
  <Application>Microsoft Macintosh PowerPoint</Application>
  <PresentationFormat>Letter Paper (8.5x11 in)</PresentationFormat>
  <Paragraphs>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ray Campbell</dc:creator>
  <cp:lastModifiedBy>Moray Campbell</cp:lastModifiedBy>
  <cp:revision>1</cp:revision>
  <dcterms:created xsi:type="dcterms:W3CDTF">2023-02-21T19:46:04Z</dcterms:created>
  <dcterms:modified xsi:type="dcterms:W3CDTF">2023-02-21T19:47:27Z</dcterms:modified>
</cp:coreProperties>
</file>